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10"/>
  </p:notesMasterIdLst>
  <p:sldIdLst>
    <p:sldId id="279" r:id="rId5"/>
    <p:sldId id="273" r:id="rId6"/>
    <p:sldId id="282" r:id="rId7"/>
    <p:sldId id="283" r:id="rId8"/>
    <p:sldId id="284" r:id="rId9"/>
  </p:sldIdLst>
  <p:sldSz cx="12192000" cy="16256000"/>
  <p:notesSz cx="6797675" cy="9929813"/>
  <p:custDataLst>
    <p:tags r:id="rId11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ianne Martinic" initials="MM" lastIdx="22" clrIdx="0">
    <p:extLst>
      <p:ext uri="{19B8F6BF-5375-455C-9EA6-DF929625EA0E}">
        <p15:presenceInfo xmlns:p15="http://schemas.microsoft.com/office/powerpoint/2012/main" userId="S::marianne.martinic@idorsia.com::9a3ea853-63be-424a-8824-d1c4a042de13" providerId="AD"/>
      </p:ext>
    </p:extLst>
  </p:cmAuthor>
  <p:cmAuthor id="2" name="Estelle Gerossier-Creusat" initials="EG" lastIdx="10" clrIdx="1">
    <p:extLst>
      <p:ext uri="{19B8F6BF-5375-455C-9EA6-DF929625EA0E}">
        <p15:presenceInfo xmlns:p15="http://schemas.microsoft.com/office/powerpoint/2012/main" userId="S::estelle.gerossier-creusat@idorsia.com::9e4e0922-4659-4724-bf48-d4f51b6526f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0000"/>
    <a:srgbClr val="EE01F5"/>
    <a:srgbClr val="F9A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9" d="100"/>
          <a:sy n="89" d="100"/>
        </p:scale>
        <p:origin x="782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gs" Target="tags/tag1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1-11-23T09:50:43.819" idx="21">
    <p:pos x="1214" y="3356"/>
    <p:text>I replaced in the figure legend the CD3 labeling  "fuchsia" with "red" as the double-stain of CD3 (red)and CD45 (blue) renders the double-positively stained cells fuchsia</p:text>
    <p:extLst>
      <p:ext uri="{C676402C-5697-4E1C-873F-D02D1690AC5C}">
        <p15:threadingInfo xmlns:p15="http://schemas.microsoft.com/office/powerpoint/2012/main" timeZoneBias="-60"/>
      </p:ext>
    </p:extLst>
  </p:cm>
  <p:cm authorId="1" dt="2021-11-23T09:53:13.136" idx="22">
    <p:pos x="878" y="955"/>
    <p:text>I changed the color from fuchsia to red to fit with the text</p:text>
    <p:extLst>
      <p:ext uri="{C676402C-5697-4E1C-873F-D02D1690AC5C}">
        <p15:threadingInfo xmlns:p15="http://schemas.microsoft.com/office/powerpoint/2012/main" timeZoneBias="-60"/>
      </p:ext>
    </p:extLst>
  </p:cm>
</p:cmLst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13" Type="http://schemas.openxmlformats.org/officeDocument/2006/relationships/image" Target="../media/image16.emf"/><Relationship Id="rId18" Type="http://schemas.openxmlformats.org/officeDocument/2006/relationships/image" Target="../media/image21.emf"/><Relationship Id="rId26" Type="http://schemas.openxmlformats.org/officeDocument/2006/relationships/image" Target="../media/image29.emf"/><Relationship Id="rId3" Type="http://schemas.openxmlformats.org/officeDocument/2006/relationships/image" Target="../media/image6.emf"/><Relationship Id="rId21" Type="http://schemas.openxmlformats.org/officeDocument/2006/relationships/image" Target="../media/image24.emf"/><Relationship Id="rId7" Type="http://schemas.openxmlformats.org/officeDocument/2006/relationships/image" Target="../media/image10.emf"/><Relationship Id="rId12" Type="http://schemas.openxmlformats.org/officeDocument/2006/relationships/image" Target="../media/image15.emf"/><Relationship Id="rId17" Type="http://schemas.openxmlformats.org/officeDocument/2006/relationships/image" Target="../media/image20.emf"/><Relationship Id="rId25" Type="http://schemas.openxmlformats.org/officeDocument/2006/relationships/image" Target="../media/image28.emf"/><Relationship Id="rId2" Type="http://schemas.openxmlformats.org/officeDocument/2006/relationships/image" Target="../media/image5.emf"/><Relationship Id="rId16" Type="http://schemas.openxmlformats.org/officeDocument/2006/relationships/image" Target="../media/image19.emf"/><Relationship Id="rId20" Type="http://schemas.openxmlformats.org/officeDocument/2006/relationships/image" Target="../media/image23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11" Type="http://schemas.openxmlformats.org/officeDocument/2006/relationships/image" Target="../media/image14.emf"/><Relationship Id="rId24" Type="http://schemas.openxmlformats.org/officeDocument/2006/relationships/image" Target="../media/image27.emf"/><Relationship Id="rId5" Type="http://schemas.openxmlformats.org/officeDocument/2006/relationships/image" Target="../media/image8.emf"/><Relationship Id="rId15" Type="http://schemas.openxmlformats.org/officeDocument/2006/relationships/image" Target="../media/image18.emf"/><Relationship Id="rId23" Type="http://schemas.openxmlformats.org/officeDocument/2006/relationships/image" Target="../media/image26.emf"/><Relationship Id="rId10" Type="http://schemas.openxmlformats.org/officeDocument/2006/relationships/image" Target="../media/image13.emf"/><Relationship Id="rId19" Type="http://schemas.openxmlformats.org/officeDocument/2006/relationships/image" Target="../media/image22.emf"/><Relationship Id="rId4" Type="http://schemas.openxmlformats.org/officeDocument/2006/relationships/image" Target="../media/image7.emf"/><Relationship Id="rId9" Type="http://schemas.openxmlformats.org/officeDocument/2006/relationships/image" Target="../media/image12.emf"/><Relationship Id="rId14" Type="http://schemas.openxmlformats.org/officeDocument/2006/relationships/image" Target="../media/image17.emf"/><Relationship Id="rId22" Type="http://schemas.openxmlformats.org/officeDocument/2006/relationships/image" Target="../media/image25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13" Type="http://schemas.openxmlformats.org/officeDocument/2006/relationships/image" Target="../media/image42.emf"/><Relationship Id="rId18" Type="http://schemas.openxmlformats.org/officeDocument/2006/relationships/image" Target="../media/image47.emf"/><Relationship Id="rId26" Type="http://schemas.openxmlformats.org/officeDocument/2006/relationships/image" Target="../media/image55.emf"/><Relationship Id="rId3" Type="http://schemas.openxmlformats.org/officeDocument/2006/relationships/image" Target="../media/image32.emf"/><Relationship Id="rId21" Type="http://schemas.openxmlformats.org/officeDocument/2006/relationships/image" Target="../media/image50.emf"/><Relationship Id="rId7" Type="http://schemas.openxmlformats.org/officeDocument/2006/relationships/image" Target="../media/image36.emf"/><Relationship Id="rId12" Type="http://schemas.openxmlformats.org/officeDocument/2006/relationships/image" Target="../media/image41.emf"/><Relationship Id="rId17" Type="http://schemas.openxmlformats.org/officeDocument/2006/relationships/image" Target="../media/image46.emf"/><Relationship Id="rId25" Type="http://schemas.openxmlformats.org/officeDocument/2006/relationships/image" Target="../media/image54.emf"/><Relationship Id="rId2" Type="http://schemas.openxmlformats.org/officeDocument/2006/relationships/image" Target="../media/image31.emf"/><Relationship Id="rId16" Type="http://schemas.openxmlformats.org/officeDocument/2006/relationships/image" Target="../media/image45.emf"/><Relationship Id="rId20" Type="http://schemas.openxmlformats.org/officeDocument/2006/relationships/image" Target="../media/image49.emf"/><Relationship Id="rId1" Type="http://schemas.openxmlformats.org/officeDocument/2006/relationships/image" Target="../media/image30.emf"/><Relationship Id="rId6" Type="http://schemas.openxmlformats.org/officeDocument/2006/relationships/image" Target="../media/image35.emf"/><Relationship Id="rId11" Type="http://schemas.openxmlformats.org/officeDocument/2006/relationships/image" Target="../media/image40.emf"/><Relationship Id="rId24" Type="http://schemas.openxmlformats.org/officeDocument/2006/relationships/image" Target="../media/image53.emf"/><Relationship Id="rId5" Type="http://schemas.openxmlformats.org/officeDocument/2006/relationships/image" Target="../media/image34.emf"/><Relationship Id="rId15" Type="http://schemas.openxmlformats.org/officeDocument/2006/relationships/image" Target="../media/image44.emf"/><Relationship Id="rId23" Type="http://schemas.openxmlformats.org/officeDocument/2006/relationships/image" Target="../media/image52.emf"/><Relationship Id="rId10" Type="http://schemas.openxmlformats.org/officeDocument/2006/relationships/image" Target="../media/image39.emf"/><Relationship Id="rId19" Type="http://schemas.openxmlformats.org/officeDocument/2006/relationships/image" Target="../media/image48.emf"/><Relationship Id="rId4" Type="http://schemas.openxmlformats.org/officeDocument/2006/relationships/image" Target="../media/image33.emf"/><Relationship Id="rId9" Type="http://schemas.openxmlformats.org/officeDocument/2006/relationships/image" Target="../media/image38.emf"/><Relationship Id="rId14" Type="http://schemas.openxmlformats.org/officeDocument/2006/relationships/image" Target="../media/image43.emf"/><Relationship Id="rId22" Type="http://schemas.openxmlformats.org/officeDocument/2006/relationships/image" Target="../media/image5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903573-89A3-42E2-99FC-E2AF051199BC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8722"/>
            <a:ext cx="543814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FE0BBC-47EC-4AA6-8D62-E74D9B3E51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957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088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756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876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856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73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279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86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592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3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095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65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78E1B-2539-4772-9DFC-D7985D7D3F9A}" type="datetimeFigureOut">
              <a:rPr lang="en-US" smtClean="0"/>
              <a:t>23.11.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F359A-E3B1-4C81-9E59-D5F79E087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479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comments" Target="../comments/commen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8.bin"/><Relationship Id="rId18" Type="http://schemas.openxmlformats.org/officeDocument/2006/relationships/image" Target="../media/image11.emf"/><Relationship Id="rId26" Type="http://schemas.openxmlformats.org/officeDocument/2006/relationships/image" Target="../media/image15.emf"/><Relationship Id="rId39" Type="http://schemas.openxmlformats.org/officeDocument/2006/relationships/oleObject" Target="../embeddings/oleObject21.bin"/><Relationship Id="rId3" Type="http://schemas.openxmlformats.org/officeDocument/2006/relationships/oleObject" Target="../embeddings/oleObject3.bin"/><Relationship Id="rId21" Type="http://schemas.openxmlformats.org/officeDocument/2006/relationships/oleObject" Target="../embeddings/oleObject12.bin"/><Relationship Id="rId34" Type="http://schemas.openxmlformats.org/officeDocument/2006/relationships/image" Target="../media/image19.emf"/><Relationship Id="rId42" Type="http://schemas.openxmlformats.org/officeDocument/2006/relationships/image" Target="../media/image23.emf"/><Relationship Id="rId47" Type="http://schemas.openxmlformats.org/officeDocument/2006/relationships/oleObject" Target="../embeddings/oleObject25.bin"/><Relationship Id="rId50" Type="http://schemas.openxmlformats.org/officeDocument/2006/relationships/image" Target="../media/image27.emf"/><Relationship Id="rId7" Type="http://schemas.openxmlformats.org/officeDocument/2006/relationships/oleObject" Target="../embeddings/oleObject5.bin"/><Relationship Id="rId12" Type="http://schemas.openxmlformats.org/officeDocument/2006/relationships/image" Target="../media/image8.emf"/><Relationship Id="rId17" Type="http://schemas.openxmlformats.org/officeDocument/2006/relationships/oleObject" Target="../embeddings/oleObject10.bin"/><Relationship Id="rId25" Type="http://schemas.openxmlformats.org/officeDocument/2006/relationships/oleObject" Target="../embeddings/oleObject14.bin"/><Relationship Id="rId33" Type="http://schemas.openxmlformats.org/officeDocument/2006/relationships/oleObject" Target="../embeddings/oleObject18.bin"/><Relationship Id="rId38" Type="http://schemas.openxmlformats.org/officeDocument/2006/relationships/image" Target="../media/image21.emf"/><Relationship Id="rId46" Type="http://schemas.openxmlformats.org/officeDocument/2006/relationships/image" Target="../media/image25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0.emf"/><Relationship Id="rId20" Type="http://schemas.openxmlformats.org/officeDocument/2006/relationships/image" Target="../media/image12.emf"/><Relationship Id="rId29" Type="http://schemas.openxmlformats.org/officeDocument/2006/relationships/oleObject" Target="../embeddings/oleObject16.bin"/><Relationship Id="rId41" Type="http://schemas.openxmlformats.org/officeDocument/2006/relationships/oleObject" Target="../embeddings/oleObject22.bin"/><Relationship Id="rId54" Type="http://schemas.openxmlformats.org/officeDocument/2006/relationships/image" Target="../media/image29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7.bin"/><Relationship Id="rId24" Type="http://schemas.openxmlformats.org/officeDocument/2006/relationships/image" Target="../media/image14.emf"/><Relationship Id="rId32" Type="http://schemas.openxmlformats.org/officeDocument/2006/relationships/image" Target="../media/image18.emf"/><Relationship Id="rId37" Type="http://schemas.openxmlformats.org/officeDocument/2006/relationships/oleObject" Target="../embeddings/oleObject20.bin"/><Relationship Id="rId40" Type="http://schemas.openxmlformats.org/officeDocument/2006/relationships/image" Target="../media/image22.emf"/><Relationship Id="rId45" Type="http://schemas.openxmlformats.org/officeDocument/2006/relationships/oleObject" Target="../embeddings/oleObject24.bin"/><Relationship Id="rId53" Type="http://schemas.openxmlformats.org/officeDocument/2006/relationships/oleObject" Target="../embeddings/oleObject28.bin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23" Type="http://schemas.openxmlformats.org/officeDocument/2006/relationships/oleObject" Target="../embeddings/oleObject13.bin"/><Relationship Id="rId28" Type="http://schemas.openxmlformats.org/officeDocument/2006/relationships/image" Target="../media/image16.emf"/><Relationship Id="rId36" Type="http://schemas.openxmlformats.org/officeDocument/2006/relationships/image" Target="../media/image20.emf"/><Relationship Id="rId49" Type="http://schemas.openxmlformats.org/officeDocument/2006/relationships/oleObject" Target="../embeddings/oleObject26.bin"/><Relationship Id="rId10" Type="http://schemas.openxmlformats.org/officeDocument/2006/relationships/image" Target="../media/image7.emf"/><Relationship Id="rId19" Type="http://schemas.openxmlformats.org/officeDocument/2006/relationships/oleObject" Target="../embeddings/oleObject11.bin"/><Relationship Id="rId31" Type="http://schemas.openxmlformats.org/officeDocument/2006/relationships/oleObject" Target="../embeddings/oleObject17.bin"/><Relationship Id="rId44" Type="http://schemas.openxmlformats.org/officeDocument/2006/relationships/image" Target="../media/image24.emf"/><Relationship Id="rId52" Type="http://schemas.openxmlformats.org/officeDocument/2006/relationships/image" Target="../media/image28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9.emf"/><Relationship Id="rId22" Type="http://schemas.openxmlformats.org/officeDocument/2006/relationships/image" Target="../media/image13.emf"/><Relationship Id="rId27" Type="http://schemas.openxmlformats.org/officeDocument/2006/relationships/oleObject" Target="../embeddings/oleObject15.bin"/><Relationship Id="rId30" Type="http://schemas.openxmlformats.org/officeDocument/2006/relationships/image" Target="../media/image17.emf"/><Relationship Id="rId35" Type="http://schemas.openxmlformats.org/officeDocument/2006/relationships/oleObject" Target="../embeddings/oleObject19.bin"/><Relationship Id="rId43" Type="http://schemas.openxmlformats.org/officeDocument/2006/relationships/oleObject" Target="../embeddings/oleObject23.bin"/><Relationship Id="rId48" Type="http://schemas.openxmlformats.org/officeDocument/2006/relationships/image" Target="../media/image26.emf"/><Relationship Id="rId8" Type="http://schemas.openxmlformats.org/officeDocument/2006/relationships/image" Target="../media/image6.emf"/><Relationship Id="rId51" Type="http://schemas.openxmlformats.org/officeDocument/2006/relationships/oleObject" Target="../embeddings/oleObject27.bin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34.bin"/><Relationship Id="rId18" Type="http://schemas.openxmlformats.org/officeDocument/2006/relationships/image" Target="../media/image37.emf"/><Relationship Id="rId26" Type="http://schemas.openxmlformats.org/officeDocument/2006/relationships/image" Target="../media/image41.emf"/><Relationship Id="rId39" Type="http://schemas.openxmlformats.org/officeDocument/2006/relationships/oleObject" Target="../embeddings/oleObject47.bin"/><Relationship Id="rId3" Type="http://schemas.openxmlformats.org/officeDocument/2006/relationships/oleObject" Target="../embeddings/oleObject29.bin"/><Relationship Id="rId21" Type="http://schemas.openxmlformats.org/officeDocument/2006/relationships/oleObject" Target="../embeddings/oleObject38.bin"/><Relationship Id="rId34" Type="http://schemas.openxmlformats.org/officeDocument/2006/relationships/image" Target="../media/image45.emf"/><Relationship Id="rId42" Type="http://schemas.openxmlformats.org/officeDocument/2006/relationships/image" Target="../media/image49.emf"/><Relationship Id="rId47" Type="http://schemas.openxmlformats.org/officeDocument/2006/relationships/oleObject" Target="../embeddings/oleObject51.bin"/><Relationship Id="rId50" Type="http://schemas.openxmlformats.org/officeDocument/2006/relationships/image" Target="../media/image53.emf"/><Relationship Id="rId7" Type="http://schemas.openxmlformats.org/officeDocument/2006/relationships/oleObject" Target="../embeddings/oleObject31.bin"/><Relationship Id="rId12" Type="http://schemas.openxmlformats.org/officeDocument/2006/relationships/image" Target="../media/image34.emf"/><Relationship Id="rId17" Type="http://schemas.openxmlformats.org/officeDocument/2006/relationships/oleObject" Target="../embeddings/oleObject36.bin"/><Relationship Id="rId25" Type="http://schemas.openxmlformats.org/officeDocument/2006/relationships/oleObject" Target="../embeddings/oleObject40.bin"/><Relationship Id="rId33" Type="http://schemas.openxmlformats.org/officeDocument/2006/relationships/oleObject" Target="../embeddings/oleObject44.bin"/><Relationship Id="rId38" Type="http://schemas.openxmlformats.org/officeDocument/2006/relationships/image" Target="../media/image47.emf"/><Relationship Id="rId46" Type="http://schemas.openxmlformats.org/officeDocument/2006/relationships/image" Target="../media/image51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6.emf"/><Relationship Id="rId20" Type="http://schemas.openxmlformats.org/officeDocument/2006/relationships/image" Target="../media/image38.emf"/><Relationship Id="rId29" Type="http://schemas.openxmlformats.org/officeDocument/2006/relationships/oleObject" Target="../embeddings/oleObject42.bin"/><Relationship Id="rId41" Type="http://schemas.openxmlformats.org/officeDocument/2006/relationships/oleObject" Target="../embeddings/oleObject48.bin"/><Relationship Id="rId54" Type="http://schemas.openxmlformats.org/officeDocument/2006/relationships/image" Target="../media/image55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31.emf"/><Relationship Id="rId11" Type="http://schemas.openxmlformats.org/officeDocument/2006/relationships/oleObject" Target="../embeddings/oleObject33.bin"/><Relationship Id="rId24" Type="http://schemas.openxmlformats.org/officeDocument/2006/relationships/image" Target="../media/image40.emf"/><Relationship Id="rId32" Type="http://schemas.openxmlformats.org/officeDocument/2006/relationships/image" Target="../media/image44.emf"/><Relationship Id="rId37" Type="http://schemas.openxmlformats.org/officeDocument/2006/relationships/oleObject" Target="../embeddings/oleObject46.bin"/><Relationship Id="rId40" Type="http://schemas.openxmlformats.org/officeDocument/2006/relationships/image" Target="../media/image48.emf"/><Relationship Id="rId45" Type="http://schemas.openxmlformats.org/officeDocument/2006/relationships/oleObject" Target="../embeddings/oleObject50.bin"/><Relationship Id="rId53" Type="http://schemas.openxmlformats.org/officeDocument/2006/relationships/oleObject" Target="../embeddings/oleObject54.bin"/><Relationship Id="rId5" Type="http://schemas.openxmlformats.org/officeDocument/2006/relationships/oleObject" Target="../embeddings/oleObject30.bin"/><Relationship Id="rId15" Type="http://schemas.openxmlformats.org/officeDocument/2006/relationships/oleObject" Target="../embeddings/oleObject35.bin"/><Relationship Id="rId23" Type="http://schemas.openxmlformats.org/officeDocument/2006/relationships/oleObject" Target="../embeddings/oleObject39.bin"/><Relationship Id="rId28" Type="http://schemas.openxmlformats.org/officeDocument/2006/relationships/image" Target="../media/image42.emf"/><Relationship Id="rId36" Type="http://schemas.openxmlformats.org/officeDocument/2006/relationships/image" Target="../media/image46.emf"/><Relationship Id="rId49" Type="http://schemas.openxmlformats.org/officeDocument/2006/relationships/oleObject" Target="../embeddings/oleObject52.bin"/><Relationship Id="rId10" Type="http://schemas.openxmlformats.org/officeDocument/2006/relationships/image" Target="../media/image33.emf"/><Relationship Id="rId19" Type="http://schemas.openxmlformats.org/officeDocument/2006/relationships/oleObject" Target="../embeddings/oleObject37.bin"/><Relationship Id="rId31" Type="http://schemas.openxmlformats.org/officeDocument/2006/relationships/oleObject" Target="../embeddings/oleObject43.bin"/><Relationship Id="rId44" Type="http://schemas.openxmlformats.org/officeDocument/2006/relationships/image" Target="../media/image50.emf"/><Relationship Id="rId52" Type="http://schemas.openxmlformats.org/officeDocument/2006/relationships/image" Target="../media/image54.emf"/><Relationship Id="rId4" Type="http://schemas.openxmlformats.org/officeDocument/2006/relationships/image" Target="../media/image30.emf"/><Relationship Id="rId9" Type="http://schemas.openxmlformats.org/officeDocument/2006/relationships/oleObject" Target="../embeddings/oleObject32.bin"/><Relationship Id="rId14" Type="http://schemas.openxmlformats.org/officeDocument/2006/relationships/image" Target="../media/image35.emf"/><Relationship Id="rId22" Type="http://schemas.openxmlformats.org/officeDocument/2006/relationships/image" Target="../media/image39.emf"/><Relationship Id="rId27" Type="http://schemas.openxmlformats.org/officeDocument/2006/relationships/oleObject" Target="../embeddings/oleObject41.bin"/><Relationship Id="rId30" Type="http://schemas.openxmlformats.org/officeDocument/2006/relationships/image" Target="../media/image43.emf"/><Relationship Id="rId35" Type="http://schemas.openxmlformats.org/officeDocument/2006/relationships/oleObject" Target="../embeddings/oleObject45.bin"/><Relationship Id="rId43" Type="http://schemas.openxmlformats.org/officeDocument/2006/relationships/oleObject" Target="../embeddings/oleObject49.bin"/><Relationship Id="rId48" Type="http://schemas.openxmlformats.org/officeDocument/2006/relationships/image" Target="../media/image52.emf"/><Relationship Id="rId8" Type="http://schemas.openxmlformats.org/officeDocument/2006/relationships/image" Target="../media/image32.emf"/><Relationship Id="rId51" Type="http://schemas.openxmlformats.org/officeDocument/2006/relationships/oleObject" Target="../embeddings/oleObject53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E3C023B3-E056-452D-93B7-97C3F8E5B034}"/>
              </a:ext>
            </a:extLst>
          </p:cNvPr>
          <p:cNvSpPr txBox="1">
            <a:spLocks/>
          </p:cNvSpPr>
          <p:nvPr/>
        </p:nvSpPr>
        <p:spPr>
          <a:xfrm>
            <a:off x="197762" y="159995"/>
            <a:ext cx="5747344" cy="426667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Supplementary figure 1</a:t>
            </a: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90D1B04F-D61C-44E5-AB63-51A661C6076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52677" y="1156607"/>
          <a:ext cx="4413250" cy="3167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3" imgW="5517279" imgH="3956652" progId="Prism8.Document">
                  <p:embed/>
                </p:oleObj>
              </mc:Choice>
              <mc:Fallback>
                <p:oleObj name="Prism 8" r:id="rId3" imgW="5517279" imgH="3956652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90D1B04F-D61C-44E5-AB63-51A661C607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2677" y="1156607"/>
                        <a:ext cx="4413250" cy="3167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0129E52-1D1D-4BB7-8952-8E0DACC59964}"/>
              </a:ext>
            </a:extLst>
          </p:cNvPr>
          <p:cNvSpPr txBox="1"/>
          <p:nvPr/>
        </p:nvSpPr>
        <p:spPr>
          <a:xfrm>
            <a:off x="664028" y="870857"/>
            <a:ext cx="4094775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rum anti-AdV5 antibody </a:t>
            </a:r>
            <a:r>
              <a:rPr lang="en-US" b="1" err="1">
                <a:latin typeface="Calibri" panose="020F0502020204030204"/>
              </a:rPr>
              <a:t>titres</a:t>
            </a: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(day 15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1A4FD72-7393-4C72-840E-6864EE3A9289}"/>
              </a:ext>
            </a:extLst>
          </p:cNvPr>
          <p:cNvSpPr txBox="1"/>
          <p:nvPr/>
        </p:nvSpPr>
        <p:spPr>
          <a:xfrm>
            <a:off x="565078" y="4613097"/>
            <a:ext cx="4397340" cy="230832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defRPr/>
            </a:pP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rum anti-AdV5 IgG ELISA </a:t>
            </a:r>
            <a:r>
              <a:rPr lang="en-US" err="1">
                <a:latin typeface="Calibri" panose="020F0502020204030204"/>
              </a:rPr>
              <a:t>titres</a:t>
            </a:r>
            <a:r>
              <a:rPr lang="en-US">
                <a:latin typeface="Calibri" panose="020F0502020204030204"/>
              </a:rPr>
              <a:t> 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 vehicle and early therapeutic </a:t>
            </a:r>
            <a:r>
              <a:rPr kumimoji="0" lang="en-US" sz="1800" b="0" i="0" u="none" strike="noStrike" kern="1200" cap="none" spc="0" normalizeH="0" baseline="0" noProof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enerimod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reated animals at the end of the study (day 15). Results represented as mean ± SEM of three independent experiments with 3-4 mice per group. AdV5, </a:t>
            </a:r>
            <a:r>
              <a:rPr lang="en-US">
                <a:latin typeface="Calibri" panose="020F0502020204030204"/>
              </a:rPr>
              <a:t>adenovirus type 5; </a:t>
            </a:r>
            <a:r>
              <a:rPr lang="en-US"/>
              <a:t>Tx, therapeutic; </a:t>
            </a:r>
            <a:r>
              <a:rPr kumimoji="0" 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M, standard error of the mean.</a:t>
            </a:r>
            <a:r>
              <a:rPr lang="en-US">
                <a:latin typeface="Calibri" panose="020F0502020204030204"/>
              </a:rPr>
              <a:t> </a:t>
            </a:r>
            <a:endParaRPr kumimoji="0" lang="en-US" sz="18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63134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E3C023B3-E056-452D-93B7-97C3F8E5B034}"/>
              </a:ext>
            </a:extLst>
          </p:cNvPr>
          <p:cNvSpPr txBox="1">
            <a:spLocks/>
          </p:cNvSpPr>
          <p:nvPr/>
        </p:nvSpPr>
        <p:spPr>
          <a:xfrm>
            <a:off x="197762" y="159995"/>
            <a:ext cx="5747344" cy="426667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Supplementary figure 2</a:t>
            </a: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3E2F9DD-9752-4F74-88CF-887F1F56612E}"/>
              </a:ext>
            </a:extLst>
          </p:cNvPr>
          <p:cNvSpPr txBox="1"/>
          <p:nvPr/>
        </p:nvSpPr>
        <p:spPr>
          <a:xfrm>
            <a:off x="145756" y="1117657"/>
            <a:ext cx="480291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raining cervical lymph node microphotograph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(day 15) </a:t>
            </a:r>
            <a:b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D3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00CC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D19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0924E9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D4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A5FFFF-0286-46D8-B78B-CAE0ACC412F8}"/>
              </a:ext>
            </a:extLst>
          </p:cNvPr>
          <p:cNvSpPr txBox="1"/>
          <p:nvPr/>
        </p:nvSpPr>
        <p:spPr>
          <a:xfrm>
            <a:off x="2639265" y="1931704"/>
            <a:ext cx="16289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arly Tx Cenerimo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93A175-E3BD-4462-8C06-F60DE6D1536C}"/>
              </a:ext>
            </a:extLst>
          </p:cNvPr>
          <p:cNvSpPr txBox="1"/>
          <p:nvPr/>
        </p:nvSpPr>
        <p:spPr>
          <a:xfrm>
            <a:off x="1214589" y="1931704"/>
            <a:ext cx="7148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ehicle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E7AACED5-1692-4034-A228-820B98014823}"/>
              </a:ext>
            </a:extLst>
          </p:cNvPr>
          <p:cNvGrpSpPr/>
          <p:nvPr/>
        </p:nvGrpSpPr>
        <p:grpSpPr>
          <a:xfrm>
            <a:off x="566806" y="2184979"/>
            <a:ext cx="3796992" cy="2513478"/>
            <a:chOff x="701585" y="3719265"/>
            <a:chExt cx="3796992" cy="2513478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485E787-8ED6-42F3-975E-40976680FD1E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40762" t="13004" b="44942"/>
            <a:stretch/>
          </p:blipFill>
          <p:spPr>
            <a:xfrm>
              <a:off x="701585" y="3719265"/>
              <a:ext cx="1887288" cy="1211126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2B498FC5-FDE0-4057-99EF-8430C83827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60886" r="60803" b="10094"/>
            <a:stretch/>
          </p:blipFill>
          <p:spPr>
            <a:xfrm>
              <a:off x="2610879" y="4962434"/>
              <a:ext cx="1887698" cy="1253517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87F352BD-BB80-417B-A86D-67C95D34E2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0762" t="56424" b="-837"/>
            <a:stretch/>
          </p:blipFill>
          <p:spPr>
            <a:xfrm>
              <a:off x="701585" y="4953642"/>
              <a:ext cx="1887288" cy="1279101"/>
            </a:xfrm>
            <a:prstGeom prst="rect">
              <a:avLst/>
            </a:prstGeom>
          </p:spPr>
        </p:pic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0A9D9344-6343-4AF9-9A6E-F31CEB3EE387}"/>
                </a:ext>
              </a:extLst>
            </p:cNvPr>
            <p:cNvGrpSpPr/>
            <p:nvPr/>
          </p:nvGrpSpPr>
          <p:grpSpPr>
            <a:xfrm>
              <a:off x="2610879" y="3719265"/>
              <a:ext cx="1887698" cy="1211126"/>
              <a:chOff x="33372" y="4079747"/>
              <a:chExt cx="1887698" cy="1211126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B1AA29F6-38DF-4698-84C2-EB4986636D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15919" r="60803" b="48273"/>
              <a:stretch/>
            </p:blipFill>
            <p:spPr>
              <a:xfrm>
                <a:off x="217825" y="4079747"/>
                <a:ext cx="1466595" cy="1211126"/>
              </a:xfrm>
              <a:prstGeom prst="rect">
                <a:avLst/>
              </a:prstGeom>
            </p:spPr>
          </p:pic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FA64B36E-DD1C-4DFB-9C58-09DCBDA4BA0F}"/>
                  </a:ext>
                </a:extLst>
              </p:cNvPr>
              <p:cNvSpPr/>
              <p:nvPr/>
            </p:nvSpPr>
            <p:spPr>
              <a:xfrm>
                <a:off x="33372" y="4080026"/>
                <a:ext cx="255739" cy="1210847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17813D2B-C82C-442D-9F23-7DCC6CB5D11C}"/>
                  </a:ext>
                </a:extLst>
              </p:cNvPr>
              <p:cNvSpPr/>
              <p:nvPr/>
            </p:nvSpPr>
            <p:spPr>
              <a:xfrm>
                <a:off x="1665331" y="4079747"/>
                <a:ext cx="255739" cy="1211126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</p:grpSp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0DD68DE7-C265-4ABF-ABAE-5452AA06A70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843656" y="1410150"/>
          <a:ext cx="5368925" cy="3097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4" imgW="6712570" imgH="3870936" progId="Prism8.Document">
                  <p:embed/>
                </p:oleObj>
              </mc:Choice>
              <mc:Fallback>
                <p:oleObj name="Prism 8" r:id="rId4" imgW="6712570" imgH="3870936" progId="Prism8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0DD68DE7-C265-4ABF-ABAE-5452AA06A7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843656" y="1410150"/>
                        <a:ext cx="5368925" cy="3097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5D9CCC0-B0FE-446F-BB5C-07AA843A9901}"/>
              </a:ext>
            </a:extLst>
          </p:cNvPr>
          <p:cNvSpPr txBox="1"/>
          <p:nvPr/>
        </p:nvSpPr>
        <p:spPr>
          <a:xfrm>
            <a:off x="204282" y="74356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617634E-620E-4DC9-A190-E352C57F31DE}"/>
              </a:ext>
            </a:extLst>
          </p:cNvPr>
          <p:cNvSpPr txBox="1"/>
          <p:nvPr/>
        </p:nvSpPr>
        <p:spPr>
          <a:xfrm>
            <a:off x="5706894" y="74356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EE1BA4F-7E42-47D2-8B60-49F2721A29E5}"/>
              </a:ext>
            </a:extLst>
          </p:cNvPr>
          <p:cNvSpPr txBox="1"/>
          <p:nvPr/>
        </p:nvSpPr>
        <p:spPr>
          <a:xfrm>
            <a:off x="453832" y="5142277"/>
            <a:ext cx="1067308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Representative microphotographs of draining cervical lymph nodes at the end of the study (day 15), depicting CD3</a:t>
            </a:r>
            <a:r>
              <a:rPr lang="en-US" baseline="30000" dirty="0"/>
              <a:t>+</a:t>
            </a:r>
            <a:r>
              <a:rPr lang="en-US" dirty="0"/>
              <a:t> T cells (red), CD19</a:t>
            </a:r>
            <a:r>
              <a:rPr lang="en-US" baseline="30000" dirty="0"/>
              <a:t>+</a:t>
            </a:r>
            <a:r>
              <a:rPr lang="en-US" dirty="0"/>
              <a:t> B cells (green), and CD45</a:t>
            </a:r>
            <a:r>
              <a:rPr lang="en-US" baseline="30000" dirty="0"/>
              <a:t>+</a:t>
            </a:r>
            <a:r>
              <a:rPr lang="en-US" dirty="0"/>
              <a:t> leukocytes (blue) of vehicle and early therapeutic cenerimod treated animals, as shown by immunofluorescence. (B) Cervical lymph node chemokine mRNA levels (CCL19, CXCL13, LT-a, LT-β) in vehicle and early therapeutic cenerimod treated animals at the end of the study (day 15) measured by quantitative real-time PCR; cenerimod groups are shown as a percentage of vehicle. Each data point represents the measurement of individual mice from three independent experiments with 2-3 mice per group; horizontal line indicates the median, the box indicates the upper and lower quartiles, and the whiskers indicate the minimum and maximum range (Mann-Whitney test). LT, lymphotoxin; Tx, therapeutic.</a:t>
            </a:r>
          </a:p>
        </p:txBody>
      </p:sp>
    </p:spTree>
    <p:extLst>
      <p:ext uri="{BB962C8B-B14F-4D97-AF65-F5344CB8AC3E}">
        <p14:creationId xmlns:p14="http://schemas.microsoft.com/office/powerpoint/2010/main" val="32002257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E3C023B3-E056-452D-93B7-97C3F8E5B034}"/>
              </a:ext>
            </a:extLst>
          </p:cNvPr>
          <p:cNvSpPr txBox="1">
            <a:spLocks/>
          </p:cNvSpPr>
          <p:nvPr/>
        </p:nvSpPr>
        <p:spPr>
          <a:xfrm>
            <a:off x="197762" y="159995"/>
            <a:ext cx="5747344" cy="426667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Supplementary figure 3</a:t>
            </a: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2C07404-7EE2-4DDB-BC90-BE19366D471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4188" y="1391174"/>
          <a:ext cx="2236787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0" name="Prism 8" r:id="rId3" imgW="3727765" imgH="3625671" progId="Prism8.Document">
                  <p:embed/>
                </p:oleObj>
              </mc:Choice>
              <mc:Fallback>
                <p:oleObj name="Prism 8" r:id="rId3" imgW="3727765" imgH="3625671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2C07404-7EE2-4DDB-BC90-BE19366D47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64188" y="1391174"/>
                        <a:ext cx="2236787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E7C7F2E-592B-49EF-B960-18BD61187F83}"/>
              </a:ext>
            </a:extLst>
          </p:cNvPr>
          <p:cNvSpPr txBox="1"/>
          <p:nvPr/>
        </p:nvSpPr>
        <p:spPr>
          <a:xfrm rot="16200000">
            <a:off x="-102424" y="2355500"/>
            <a:ext cx="719749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SG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BD6200A-122E-4274-A290-7D42A88651B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28060" y="3535088"/>
          <a:ext cx="2214562" cy="21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1" name="Prism 8" r:id="rId5" imgW="3691031" imgH="3656284" progId="Prism8.Document">
                  <p:embed/>
                </p:oleObj>
              </mc:Choice>
              <mc:Fallback>
                <p:oleObj name="Prism 8" r:id="rId5" imgW="3691031" imgH="3656284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BD6200A-122E-4274-A290-7D42A88651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28060" y="3535088"/>
                        <a:ext cx="2214562" cy="21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419DE70-B640-4D68-81EB-A4E171250AF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8443" y="3544613"/>
          <a:ext cx="2214562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2" name="Prism 8" r:id="rId7" imgW="3691031" imgH="3625671" progId="Prism8.Document">
                  <p:embed/>
                </p:oleObj>
              </mc:Choice>
              <mc:Fallback>
                <p:oleObj name="Prism 8" r:id="rId7" imgW="3691031" imgH="3625671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419DE70-B640-4D68-81EB-A4E171250A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8443" y="3544613"/>
                        <a:ext cx="2214562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E5650341-3339-40B7-8FD6-4C1428F788C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8632" y="5714843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3" name="Prism 8" r:id="rId9" imgW="3691031" imgH="3625671" progId="Prism8.Document">
                  <p:embed/>
                </p:oleObj>
              </mc:Choice>
              <mc:Fallback>
                <p:oleObj name="Prism 8" r:id="rId9" imgW="3691031" imgH="3625671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E5650341-3339-40B7-8FD6-4C1428F788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368632" y="5714843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C185B2B9-790E-4241-93E1-245507C41AC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89392" y="3543819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4" name="Prism 8" r:id="rId11" imgW="3691031" imgH="3625671" progId="Prism8.Document">
                  <p:embed/>
                </p:oleObj>
              </mc:Choice>
              <mc:Fallback>
                <p:oleObj name="Prism 8" r:id="rId11" imgW="3691031" imgH="3625671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C185B2B9-790E-4241-93E1-245507C41A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0089392" y="3543819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2E121567-BE6D-4DC4-B065-2DC79570488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159200" y="5710080"/>
          <a:ext cx="221456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5" name="Prism 8" r:id="rId13" imgW="3691031" imgH="3644039" progId="Prism8.Document">
                  <p:embed/>
                </p:oleObj>
              </mc:Choice>
              <mc:Fallback>
                <p:oleObj name="Prism 8" r:id="rId13" imgW="3691031" imgH="3644039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2E121567-BE6D-4DC4-B065-2DC7957048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159200" y="5710080"/>
                        <a:ext cx="2214563" cy="2185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6858EBE-9D48-4FFF-B373-028884CB69E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14847" y="7876317"/>
          <a:ext cx="221456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6" name="Prism 8" r:id="rId15" imgW="3691031" imgH="3644039" progId="Prism8.Document">
                  <p:embed/>
                </p:oleObj>
              </mc:Choice>
              <mc:Fallback>
                <p:oleObj name="Prism 8" r:id="rId15" imgW="3691031" imgH="3644039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86858EBE-9D48-4FFF-B373-028884CB69E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214847" y="7876317"/>
                        <a:ext cx="2214563" cy="2185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8E5763B9-EF5E-4252-A8CD-D390AD6BD51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3909" y="7881080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7" name="Prism 8" r:id="rId17" imgW="3691031" imgH="3628552" progId="Prism8.Document">
                  <p:embed/>
                </p:oleObj>
              </mc:Choice>
              <mc:Fallback>
                <p:oleObj name="Prism 8" r:id="rId17" imgW="3691031" imgH="3628552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8E5763B9-EF5E-4252-A8CD-D390AD6BD51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363909" y="7881080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7B3F5730-3995-4E95-AAFB-0846263B6E3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1651" y="10023129"/>
          <a:ext cx="2214563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8" name="Prism 8" r:id="rId19" imgW="3691031" imgH="3625671" progId="Prism8.Document">
                  <p:embed/>
                </p:oleObj>
              </mc:Choice>
              <mc:Fallback>
                <p:oleObj name="Prism 8" r:id="rId19" imgW="3691031" imgH="3625671" progId="Prism8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7B3F5730-3995-4E95-AAFB-0846263B6E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361651" y="10023129"/>
                        <a:ext cx="2214563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C21AEB66-C46A-4FF4-AABC-C28B1DDC97F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140317" y="7881080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9" name="Prism 8" r:id="rId21" imgW="3691031" imgH="3625671" progId="Prism8.Document">
                  <p:embed/>
                </p:oleObj>
              </mc:Choice>
              <mc:Fallback>
                <p:oleObj name="Prism 8" r:id="rId21" imgW="3691031" imgH="3625671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C21AEB66-C46A-4FF4-AABC-C28B1DDC97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8140317" y="7881080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CF5F4A2E-7A26-4D80-A998-4C0DF7CFB59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98188" y="3543819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0" name="Prism 8" r:id="rId23" imgW="3691031" imgH="3625671" progId="Prism8.Document">
                  <p:embed/>
                </p:oleObj>
              </mc:Choice>
              <mc:Fallback>
                <p:oleObj name="Prism 8" r:id="rId23" imgW="3691031" imgH="3625671" progId="Prism8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CF5F4A2E-7A26-4D80-A998-4C0DF7CFB5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298188" y="3543819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8BA2BB6-4180-4EB3-8698-5434DEDBE42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98821" y="5710080"/>
          <a:ext cx="221456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1" name="Prism 8" r:id="rId25" imgW="3691031" imgH="3644039" progId="Prism8.Document">
                  <p:embed/>
                </p:oleObj>
              </mc:Choice>
              <mc:Fallback>
                <p:oleObj name="Prism 8" r:id="rId25" imgW="3691031" imgH="3644039" progId="Prism8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78BA2BB6-4180-4EB3-8698-5434DEDBE4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298821" y="5710080"/>
                        <a:ext cx="2214563" cy="2185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1DED0662-3BEF-4718-B058-23B37A00E1E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65788" y="7881080"/>
          <a:ext cx="2236788" cy="217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2" name="Prism 8" r:id="rId27" imgW="3727765" imgH="3625671" progId="Prism8.Document">
                  <p:embed/>
                </p:oleObj>
              </mc:Choice>
              <mc:Fallback>
                <p:oleObj name="Prism 8" r:id="rId27" imgW="3727765" imgH="3625671" progId="Prism8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1DED0662-3BEF-4718-B058-23B37A00E1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0065788" y="7881080"/>
                        <a:ext cx="2236788" cy="217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98A6D84B-E136-4C34-8CCD-31BA3DD1A5D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163649" y="1391967"/>
          <a:ext cx="2214562" cy="2173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3" name="Prism 8" r:id="rId29" imgW="3691031" imgH="3619548" progId="Prism8.Document">
                  <p:embed/>
                </p:oleObj>
              </mc:Choice>
              <mc:Fallback>
                <p:oleObj name="Prism 8" r:id="rId29" imgW="3691031" imgH="3619548" progId="Prism8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98A6D84B-E136-4C34-8CCD-31BA3DD1A5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8163649" y="1391967"/>
                        <a:ext cx="2214562" cy="2173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44036C79-E187-44BC-A65B-5F951DAE327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12158" y="1391174"/>
          <a:ext cx="2214563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4" name="Prism 8" r:id="rId31" imgW="3691031" imgH="3625671" progId="Prism8.Document">
                  <p:embed/>
                </p:oleObj>
              </mc:Choice>
              <mc:Fallback>
                <p:oleObj name="Prism 8" r:id="rId31" imgW="3691031" imgH="3625671" progId="Prism8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44036C79-E187-44BC-A65B-5F951DAE32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4312158" y="1391174"/>
                        <a:ext cx="2214563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BEAA37DC-84A1-4CC2-8A84-DB128965829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37904" y="1390380"/>
          <a:ext cx="2214562" cy="217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5" name="Prism 8" r:id="rId33" imgW="3691031" imgH="3625671" progId="Prism8.Document">
                  <p:embed/>
                </p:oleObj>
              </mc:Choice>
              <mc:Fallback>
                <p:oleObj name="Prism 8" r:id="rId33" imgW="3691031" imgH="3625671" progId="Prism8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BEAA37DC-84A1-4CC2-8A84-DB12896582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6237904" y="1390380"/>
                        <a:ext cx="2214562" cy="217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F843DCD5-F617-4235-BD69-CC3819551B8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17805" y="1387205"/>
          <a:ext cx="2235200" cy="2182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6" name="Prism 8" r:id="rId35" imgW="3727765" imgH="3634675" progId="Prism8.Document">
                  <p:embed/>
                </p:oleObj>
              </mc:Choice>
              <mc:Fallback>
                <p:oleObj name="Prism 8" r:id="rId35" imgW="3727765" imgH="3634675" progId="Prism8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F843DCD5-F617-4235-BD69-CC3819551B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417805" y="1387205"/>
                        <a:ext cx="2235200" cy="2182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D238EB3D-ABFC-4209-BCB4-B9D1D00A5D8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89392" y="5715637"/>
          <a:ext cx="2214562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7" name="Prism 8" r:id="rId37" imgW="3691031" imgH="3628552" progId="Prism8.Document">
                  <p:embed/>
                </p:oleObj>
              </mc:Choice>
              <mc:Fallback>
                <p:oleObj name="Prism 8" r:id="rId37" imgW="3691031" imgH="3628552" progId="Prism8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D238EB3D-ABFC-4209-BCB4-B9D1D00A5D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10089392" y="5715637"/>
                        <a:ext cx="2214562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2BC9B65B-2480-418F-BF8E-6C6732E84C6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89392" y="1391174"/>
          <a:ext cx="2214562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8" name="Prism 8" r:id="rId39" imgW="3691031" imgH="3625671" progId="Prism8.Document">
                  <p:embed/>
                </p:oleObj>
              </mc:Choice>
              <mc:Fallback>
                <p:oleObj name="Prism 8" r:id="rId39" imgW="3691031" imgH="3625671" progId="Prism8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2BC9B65B-2480-418F-BF8E-6C6732E84C6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10089392" y="1391174"/>
                        <a:ext cx="2214562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CFAC58C4-8BBB-44D1-BBAD-CC073C8F3DC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89378" y="7881080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9" name="Prism 8" r:id="rId41" imgW="3691031" imgH="3625671" progId="Prism8.Document">
                  <p:embed/>
                </p:oleObj>
              </mc:Choice>
              <mc:Fallback>
                <p:oleObj name="Prism 8" r:id="rId41" imgW="3691031" imgH="3625671" progId="Prism8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CFAC58C4-8BBB-44D1-BBAD-CC073C8F3D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4289378" y="7881080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DFF1B143-75D0-4A50-B207-CF619D3821D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29011" y="5714843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0" name="Prism 8" r:id="rId43" imgW="3691031" imgH="3625671" progId="Prism8.Document">
                  <p:embed/>
                </p:oleObj>
              </mc:Choice>
              <mc:Fallback>
                <p:oleObj name="Prism 8" r:id="rId43" imgW="3691031" imgH="3625671" progId="Prism8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DFF1B143-75D0-4A50-B207-CF619D3821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6229011" y="5714843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5FE5C244-8680-41C3-A589-DE6F756A73F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8442" y="5710080"/>
          <a:ext cx="221456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1" name="Prism 8" r:id="rId45" imgW="3691031" imgH="3644039" progId="Prism8.Document">
                  <p:embed/>
                </p:oleObj>
              </mc:Choice>
              <mc:Fallback>
                <p:oleObj name="Prism 8" r:id="rId45" imgW="3691031" imgH="3644039" progId="Prism8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5FE5C244-8680-41C3-A589-DE6F756A73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438442" y="5710080"/>
                        <a:ext cx="2214563" cy="2185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8808630F-A78E-4AB2-BD2F-6B623584E56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157932" y="3543819"/>
          <a:ext cx="2216150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2" name="Prism 8" r:id="rId47" imgW="3691031" imgH="3625671" progId="Prism8.Document">
                  <p:embed/>
                </p:oleObj>
              </mc:Choice>
              <mc:Fallback>
                <p:oleObj name="Prism 8" r:id="rId47" imgW="3691031" imgH="3625671" progId="Prism8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8808630F-A78E-4AB2-BD2F-6B623584E56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8157932" y="3543819"/>
                        <a:ext cx="2216150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406FB01B-C00A-42A3-B58C-B1B75526C92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8439" y="7881874"/>
          <a:ext cx="2214563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3" name="Prism 8" r:id="rId49" imgW="3691031" imgH="3625671" progId="Prism8.Document">
                  <p:embed/>
                </p:oleObj>
              </mc:Choice>
              <mc:Fallback>
                <p:oleObj name="Prism 8" r:id="rId49" imgW="3691031" imgH="3625671" progId="Prism8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406FB01B-C00A-42A3-B58C-B1B75526C9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438439" y="7881874"/>
                        <a:ext cx="2214563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3865FA85-B7B2-408C-BDD6-081260A9CF3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8315" y="3535088"/>
          <a:ext cx="2214563" cy="21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4" name="Prism 8" r:id="rId51" imgW="3691031" imgH="3657724" progId="Prism8.Document">
                  <p:embed/>
                </p:oleObj>
              </mc:Choice>
              <mc:Fallback>
                <p:oleObj name="Prism 8" r:id="rId51" imgW="3691031" imgH="3657724" progId="Prism8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3865FA85-B7B2-408C-BDD6-081260A9CF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2368315" y="3535088"/>
                        <a:ext cx="2214563" cy="21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035D2959-F6BD-4D06-BA88-806E1CE77BD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8439" y="10022335"/>
          <a:ext cx="2214562" cy="217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5" name="Prism 8" r:id="rId53" imgW="3691031" imgH="3625671" progId="Prism8.Document">
                  <p:embed/>
                </p:oleObj>
              </mc:Choice>
              <mc:Fallback>
                <p:oleObj name="Prism 8" r:id="rId53" imgW="3691031" imgH="3625671" progId="Prism8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035D2959-F6BD-4D06-BA88-806E1CE77B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438439" y="10022335"/>
                        <a:ext cx="2214562" cy="217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82A64B99-23F9-4A4D-9E17-8D10365B7B66}"/>
              </a:ext>
            </a:extLst>
          </p:cNvPr>
          <p:cNvSpPr txBox="1"/>
          <p:nvPr/>
        </p:nvSpPr>
        <p:spPr>
          <a:xfrm rot="16200000">
            <a:off x="-102424" y="4517715"/>
            <a:ext cx="719749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SG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79BA797-D706-4892-817D-848DCEDA6C27}"/>
              </a:ext>
            </a:extLst>
          </p:cNvPr>
          <p:cNvSpPr txBox="1"/>
          <p:nvPr/>
        </p:nvSpPr>
        <p:spPr>
          <a:xfrm rot="16200000">
            <a:off x="-102424" y="6713328"/>
            <a:ext cx="719749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SG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A30198D-1F4B-4296-94ED-64EEDDE81884}"/>
              </a:ext>
            </a:extLst>
          </p:cNvPr>
          <p:cNvSpPr txBox="1"/>
          <p:nvPr/>
        </p:nvSpPr>
        <p:spPr>
          <a:xfrm rot="16200000">
            <a:off x="-102424" y="8878284"/>
            <a:ext cx="719749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SG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2D50B54-A71D-461A-BE81-DE3169D52147}"/>
              </a:ext>
            </a:extLst>
          </p:cNvPr>
          <p:cNvSpPr txBox="1"/>
          <p:nvPr/>
        </p:nvSpPr>
        <p:spPr>
          <a:xfrm rot="16200000">
            <a:off x="-91203" y="11003497"/>
            <a:ext cx="697307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S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661AF98-04AE-4554-9E26-5EEA0A65071E}"/>
              </a:ext>
            </a:extLst>
          </p:cNvPr>
          <p:cNvSpPr txBox="1"/>
          <p:nvPr/>
        </p:nvSpPr>
        <p:spPr>
          <a:xfrm>
            <a:off x="2283185" y="909557"/>
            <a:ext cx="7982901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alivary Gland inflammatory environment – E</a:t>
            </a:r>
            <a:r>
              <a:rPr kumimoji="0" lang="en-US" sz="1600" b="1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rly</a:t>
            </a:r>
            <a:r>
              <a:rPr kumimoji="0" 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therapeutic treatment (day 15)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F000A41-471A-406C-A7B8-65D81A89E675}"/>
              </a:ext>
            </a:extLst>
          </p:cNvPr>
          <p:cNvSpPr txBox="1"/>
          <p:nvPr/>
        </p:nvSpPr>
        <p:spPr>
          <a:xfrm>
            <a:off x="136634" y="12538368"/>
            <a:ext cx="1190467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/>
              <a:t>Box plots of cytokine and chemokine proteins measured in vehicle and early therapeutic cenerimod treated C57BL/6 mice at the end of the study (day 15). Each data point represents the measurement of individual mice from three independent experiments with 2-4 mice per group; horizontal line indicates the median, the box indicates the upper and lower quartiles, and the whiskers indicate the minimum and maximum range. *p&lt;0.05, **p&lt;0.01, ***p&lt;0.001 vs. vehicle group (Mann-Whitney test). SG, salivary gland. </a:t>
            </a:r>
          </a:p>
        </p:txBody>
      </p:sp>
    </p:spTree>
    <p:extLst>
      <p:ext uri="{BB962C8B-B14F-4D97-AF65-F5344CB8AC3E}">
        <p14:creationId xmlns:p14="http://schemas.microsoft.com/office/powerpoint/2010/main" val="31270233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3509F42B-30FD-497A-96C9-A7C9A6114DF5}"/>
              </a:ext>
            </a:extLst>
          </p:cNvPr>
          <p:cNvSpPr txBox="1">
            <a:spLocks/>
          </p:cNvSpPr>
          <p:nvPr/>
        </p:nvSpPr>
        <p:spPr>
          <a:xfrm>
            <a:off x="197762" y="159995"/>
            <a:ext cx="5747344" cy="426667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Supplementary figure 4</a:t>
            </a: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7EA0AED-B4AA-47E0-BD9A-A76814CCAEE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72382" y="9980314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4" name="Prism 8" r:id="rId3" imgW="3691031" imgH="3625671" progId="Prism8.Document">
                  <p:embed/>
                </p:oleObj>
              </mc:Choice>
              <mc:Fallback>
                <p:oleObj name="Prism 8" r:id="rId3" imgW="3691031" imgH="3625671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07EA0AED-B4AA-47E0-BD9A-A76814CCAE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72382" y="9980314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1C8706A-C9EA-46DB-ABCF-0995C7064F9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73445" y="5664705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5" name="Prism 8" r:id="rId5" imgW="3691031" imgH="3625671" progId="Prism8.Document">
                  <p:embed/>
                </p:oleObj>
              </mc:Choice>
              <mc:Fallback>
                <p:oleObj name="Prism 8" r:id="rId5" imgW="3691031" imgH="3625671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1C8706A-C9EA-46DB-ABCF-0995C7064F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73445" y="5664705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DEE5B65B-33B6-40DD-A65C-E6CEBAA30C9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0982" y="7802309"/>
          <a:ext cx="221456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6" name="Prism 8" r:id="rId7" imgW="3691031" imgH="3644039" progId="Prism8.Document">
                  <p:embed/>
                </p:oleObj>
              </mc:Choice>
              <mc:Fallback>
                <p:oleObj name="Prism 8" r:id="rId7" imgW="3691031" imgH="3644039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DEE5B65B-33B6-40DD-A65C-E6CEBAA30C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60982" y="7802309"/>
                        <a:ext cx="2214563" cy="2185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AEE91CC8-76B8-44D0-8369-EDACB504191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152993" y="7802309"/>
          <a:ext cx="221456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7" name="Prism 8" r:id="rId9" imgW="3691031" imgH="3644039" progId="Prism8.Document">
                  <p:embed/>
                </p:oleObj>
              </mc:Choice>
              <mc:Fallback>
                <p:oleObj name="Prism 8" r:id="rId9" imgW="3691031" imgH="3644039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AEE91CC8-76B8-44D0-8369-EDACB50419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152993" y="7802309"/>
                        <a:ext cx="2214563" cy="2185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DD0B0036-1DA7-47AD-A534-DCD7B977F6A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153725" y="5664705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8" name="Prism 8" r:id="rId11" imgW="3691031" imgH="3628552" progId="Prism8.Document">
                  <p:embed/>
                </p:oleObj>
              </mc:Choice>
              <mc:Fallback>
                <p:oleObj name="Prism 8" r:id="rId11" imgW="3691031" imgH="3628552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DD0B0036-1DA7-47AD-A534-DCD7B977F6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153725" y="5664705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AD0B66E6-A007-4AEB-8963-D29CCD8BD69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83663" y="7807866"/>
          <a:ext cx="2214563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9" name="Prism 8" r:id="rId13" imgW="3691031" imgH="3625671" progId="Prism8.Document">
                  <p:embed/>
                </p:oleObj>
              </mc:Choice>
              <mc:Fallback>
                <p:oleObj name="Prism 8" r:id="rId13" imgW="3691031" imgH="3625671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AD0B66E6-A007-4AEB-8963-D29CCD8BD6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0083663" y="7807866"/>
                        <a:ext cx="2214563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24C8AE0-50ED-45F7-A7BF-E53500B5F71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22323" y="7807072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0" name="Prism 8" r:id="rId15" imgW="3691031" imgH="3625671" progId="Prism8.Document">
                  <p:embed/>
                </p:oleObj>
              </mc:Choice>
              <mc:Fallback>
                <p:oleObj name="Prism 8" r:id="rId15" imgW="3691031" imgH="3625671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824C8AE0-50ED-45F7-A7BF-E53500B5F7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222323" y="7807072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FD12361C-8C72-467D-9127-DA3884AB21B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00067" y="5665705"/>
          <a:ext cx="2214563" cy="2171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1" name="Prism 8" r:id="rId17" imgW="3691031" imgH="3618107" progId="Prism8.Document">
                  <p:embed/>
                </p:oleObj>
              </mc:Choice>
              <mc:Fallback>
                <p:oleObj name="Prism 8" r:id="rId17" imgW="3691031" imgH="3618107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FD12361C-8C72-467D-9127-DA3884AB21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300067" y="5665705"/>
                        <a:ext cx="2214563" cy="2171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BA77D815-680D-4934-991E-9D663D70DED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9204" y="3479746"/>
          <a:ext cx="221456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2" name="Prism 8" r:id="rId19" imgW="3691031" imgH="3644039" progId="Prism8.Document">
                  <p:embed/>
                </p:oleObj>
              </mc:Choice>
              <mc:Fallback>
                <p:oleObj name="Prism 8" r:id="rId19" imgW="3691031" imgH="3644039" progId="Prism8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BA77D815-680D-4934-991E-9D663D70DE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39204" y="3479746"/>
                        <a:ext cx="2214563" cy="2185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F3578C30-4A22-4F40-A2C7-F78EA81B2B3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8086" y="7807072"/>
          <a:ext cx="2236788" cy="217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3" name="Prism 8" r:id="rId21" imgW="3727765" imgH="3625671" progId="Prism8.Document">
                  <p:embed/>
                </p:oleObj>
              </mc:Choice>
              <mc:Fallback>
                <p:oleObj name="Prism 8" r:id="rId21" imgW="3727765" imgH="3625671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F3578C30-4A22-4F40-A2C7-F78EA81B2B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08086" y="7807072"/>
                        <a:ext cx="2236788" cy="217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DA84E5ED-54D2-47A2-86D0-742263B97A8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155906" y="3485303"/>
          <a:ext cx="2214562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4" name="Prism 8" r:id="rId23" imgW="3691031" imgH="3625671" progId="Prism8.Document">
                  <p:embed/>
                </p:oleObj>
              </mc:Choice>
              <mc:Fallback>
                <p:oleObj name="Prism 8" r:id="rId23" imgW="3691031" imgH="3625671" progId="Prism8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DA84E5ED-54D2-47A2-86D0-742263B97A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8155906" y="3485303"/>
                        <a:ext cx="2214562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1EBB2261-AC0A-47F9-8593-568692AD311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93992" y="1352705"/>
          <a:ext cx="2214562" cy="2173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5" name="Prism 8" r:id="rId25" imgW="3691031" imgH="3619548" progId="Prism8.Document">
                  <p:embed/>
                </p:oleObj>
              </mc:Choice>
              <mc:Fallback>
                <p:oleObj name="Prism 8" r:id="rId25" imgW="3691031" imgH="3619548" progId="Prism8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1EBB2261-AC0A-47F9-8593-568692AD31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4293992" y="1352705"/>
                        <a:ext cx="2214562" cy="2173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E7EB896E-547C-4AF6-8264-D7E3EB6BEA0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4563" y="1343788"/>
          <a:ext cx="2214563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6" name="Prism 8" r:id="rId27" imgW="3691031" imgH="3625671" progId="Prism8.Document">
                  <p:embed/>
                </p:oleObj>
              </mc:Choice>
              <mc:Fallback>
                <p:oleObj name="Prism 8" r:id="rId27" imgW="3691031" imgH="3625671" progId="Prism8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E7EB896E-547C-4AF6-8264-D7E3EB6BEA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444563" y="1343788"/>
                        <a:ext cx="2214563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8FBD2EC0-5EB1-4260-AD38-428F7F7DA78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19250" y="1342994"/>
          <a:ext cx="2214562" cy="217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7" name="Prism 8" r:id="rId29" imgW="3691031" imgH="3625671" progId="Prism8.Document">
                  <p:embed/>
                </p:oleObj>
              </mc:Choice>
              <mc:Fallback>
                <p:oleObj name="Prism 8" r:id="rId29" imgW="3691031" imgH="3625671" progId="Prism8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8FBD2EC0-5EB1-4260-AD38-428F7F7DA7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6219250" y="1342994"/>
                        <a:ext cx="2214562" cy="217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BD9EA79F-0C1D-461C-8D3A-00DEB4371E9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9459" y="1334263"/>
          <a:ext cx="2214563" cy="219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8" name="Prism 8" r:id="rId31" imgW="3691031" imgH="3657724" progId="Prism8.Document">
                  <p:embed/>
                </p:oleObj>
              </mc:Choice>
              <mc:Fallback>
                <p:oleObj name="Prism 8" r:id="rId31" imgW="3691031" imgH="3657724" progId="Prism8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BD9EA79F-0C1D-461C-8D3A-00DEB4371E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2369459" y="1334263"/>
                        <a:ext cx="2214563" cy="2193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DF15CB08-C92E-4132-B7F4-EF6D2768650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6684" y="5658355"/>
          <a:ext cx="2214563" cy="2189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9" name="Prism 8" r:id="rId33" imgW="3691031" imgH="3646920" progId="Prism8.Document">
                  <p:embed/>
                </p:oleObj>
              </mc:Choice>
              <mc:Fallback>
                <p:oleObj name="Prism 8" r:id="rId33" imgW="3691031" imgH="3646920" progId="Prism8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DF15CB08-C92E-4132-B7F4-EF6D276865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46684" y="5658355"/>
                        <a:ext cx="2214563" cy="2189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81B9DA0E-F949-4C9C-A941-F5C991168FD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89680" y="1343788"/>
          <a:ext cx="2214562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0" name="Prism 8" r:id="rId35" imgW="3691031" imgH="3625671" progId="Prism8.Document">
                  <p:embed/>
                </p:oleObj>
              </mc:Choice>
              <mc:Fallback>
                <p:oleObj name="Prism 8" r:id="rId35" imgW="3691031" imgH="3625671" progId="Prism8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81B9DA0E-F949-4C9C-A941-F5C991168F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10089680" y="1343788"/>
                        <a:ext cx="2214562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5C881ABC-1E10-4BFE-BC5D-7E2980996C8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144145" y="1339819"/>
          <a:ext cx="2235200" cy="2182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1" name="Prism 8" r:id="rId37" imgW="3727765" imgH="3634675" progId="Prism8.Document">
                  <p:embed/>
                </p:oleObj>
              </mc:Choice>
              <mc:Fallback>
                <p:oleObj name="Prism 8" r:id="rId37" imgW="3727765" imgH="3634675" progId="Prism8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5C881ABC-1E10-4BFE-BC5D-7E2980996C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8144145" y="1339819"/>
                        <a:ext cx="2235200" cy="2182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4FBA5F8B-3585-408C-8721-B610EDA7426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19250" y="5674394"/>
          <a:ext cx="2214562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2" name="Prism 8" r:id="rId39" imgW="3691031" imgH="3628552" progId="Prism8.Document">
                  <p:embed/>
                </p:oleObj>
              </mc:Choice>
              <mc:Fallback>
                <p:oleObj name="Prism 8" r:id="rId39" imgW="3691031" imgH="3628552" progId="Prism8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4FBA5F8B-3585-408C-8721-B610EDA742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6219250" y="5674394"/>
                        <a:ext cx="2214562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1057130B-328C-4F18-9CEB-831CA25C516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8086" y="9966467"/>
          <a:ext cx="2236788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3" name="Prism 8" r:id="rId41" imgW="3727765" imgH="3625671" progId="Prism8.Document">
                  <p:embed/>
                </p:oleObj>
              </mc:Choice>
              <mc:Fallback>
                <p:oleObj name="Prism 8" r:id="rId41" imgW="3727765" imgH="3625671" progId="Prism8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1057130B-328C-4F18-9CEB-831CA25C516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408086" y="9966467"/>
                        <a:ext cx="2236788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55E75C1B-66F1-4CB4-9F2C-F92FDA773D2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96892" y="3486067"/>
          <a:ext cx="2214563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4" name="Prism 8" r:id="rId43" imgW="3691031" imgH="3625671" progId="Prism8.Document">
                  <p:embed/>
                </p:oleObj>
              </mc:Choice>
              <mc:Fallback>
                <p:oleObj name="Prism 8" r:id="rId43" imgW="3691031" imgH="3625671" progId="Prism8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55E75C1B-66F1-4CB4-9F2C-F92FDA773D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4296892" y="3486067"/>
                        <a:ext cx="2214563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59FEB818-35AC-428E-8231-0D0EFF93384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8080" y="3486067"/>
          <a:ext cx="2214562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5" name="Prism 8" r:id="rId45" imgW="3691031" imgH="3625671" progId="Prism8.Document">
                  <p:embed/>
                </p:oleObj>
              </mc:Choice>
              <mc:Fallback>
                <p:oleObj name="Prism 8" r:id="rId45" imgW="3691031" imgH="3625671" progId="Prism8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59FEB818-35AC-428E-8231-0D0EFF9338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2368080" y="3486067"/>
                        <a:ext cx="2214562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850A469C-882B-4E91-A014-C96CD406D5E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85082" y="3479746"/>
          <a:ext cx="2214563" cy="2185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6" name="Prism 8" r:id="rId47" imgW="3691031" imgH="3644039" progId="Prism8.Document">
                  <p:embed/>
                </p:oleObj>
              </mc:Choice>
              <mc:Fallback>
                <p:oleObj name="Prism 8" r:id="rId47" imgW="3691031" imgH="3644039" progId="Prism8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850A469C-882B-4E91-A014-C96CD406D5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10085082" y="3479746"/>
                        <a:ext cx="2214563" cy="2185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6BF3E77A-3C9B-49D8-AD7E-3D398769B90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80485" y="5664705"/>
          <a:ext cx="2216150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7" name="Prism 8" r:id="rId49" imgW="3691031" imgH="3625671" progId="Prism8.Document">
                  <p:embed/>
                </p:oleObj>
              </mc:Choice>
              <mc:Fallback>
                <p:oleObj name="Prism 8" r:id="rId49" imgW="3691031" imgH="3625671" progId="Prism8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6BF3E77A-3C9B-49D8-AD7E-3D398769B9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10080485" y="5664705"/>
                        <a:ext cx="2216150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4EFD7E6B-6520-4138-A244-2C6218AE533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26730" y="3485303"/>
          <a:ext cx="2214563" cy="217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8" name="Prism 8" r:id="rId51" imgW="3691031" imgH="3625671" progId="Prism8.Document">
                  <p:embed/>
                </p:oleObj>
              </mc:Choice>
              <mc:Fallback>
                <p:oleObj name="Prism 8" r:id="rId51" imgW="3691031" imgH="3625671" progId="Prism8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4EFD7E6B-6520-4138-A244-2C6218AE53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6226730" y="3485303"/>
                        <a:ext cx="2214563" cy="217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65C7DABA-6B0E-4492-A8A7-BF145BADF3C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91653" y="7807072"/>
          <a:ext cx="2214562" cy="217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9" name="Prism 8" r:id="rId53" imgW="3691031" imgH="3625671" progId="Prism8.Document">
                  <p:embed/>
                </p:oleObj>
              </mc:Choice>
              <mc:Fallback>
                <p:oleObj name="Prism 8" r:id="rId53" imgW="3691031" imgH="3625671" progId="Prism8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65C7DABA-6B0E-4492-A8A7-BF145BADF3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4"/>
                      <a:stretch>
                        <a:fillRect/>
                      </a:stretch>
                    </p:blipFill>
                    <p:spPr>
                      <a:xfrm>
                        <a:off x="4291653" y="7807072"/>
                        <a:ext cx="2214562" cy="2176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D7A0EB4E-AC06-4D1B-9955-582698C15089}"/>
              </a:ext>
            </a:extLst>
          </p:cNvPr>
          <p:cNvSpPr txBox="1"/>
          <p:nvPr/>
        </p:nvSpPr>
        <p:spPr>
          <a:xfrm rot="16200000">
            <a:off x="-257114" y="2299964"/>
            <a:ext cx="1029129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left SG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8939F1E-65E7-4F7A-A38E-363FBA252FBA}"/>
              </a:ext>
            </a:extLst>
          </p:cNvPr>
          <p:cNvSpPr txBox="1"/>
          <p:nvPr/>
        </p:nvSpPr>
        <p:spPr>
          <a:xfrm rot="16200000">
            <a:off x="-257113" y="4462179"/>
            <a:ext cx="1029128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left SG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D15B8F4-E97D-437B-957A-792ED0CE0821}"/>
              </a:ext>
            </a:extLst>
          </p:cNvPr>
          <p:cNvSpPr txBox="1"/>
          <p:nvPr/>
        </p:nvSpPr>
        <p:spPr>
          <a:xfrm rot="16200000">
            <a:off x="-257113" y="6657792"/>
            <a:ext cx="1029128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left SG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3FBF921-9A23-4112-A9F1-E8377B58AAF8}"/>
              </a:ext>
            </a:extLst>
          </p:cNvPr>
          <p:cNvSpPr txBox="1"/>
          <p:nvPr/>
        </p:nvSpPr>
        <p:spPr>
          <a:xfrm rot="16200000">
            <a:off x="-257113" y="8822748"/>
            <a:ext cx="1029128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left S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4B8D3D8-C161-4C11-AB6A-FA4A998522DF}"/>
              </a:ext>
            </a:extLst>
          </p:cNvPr>
          <p:cNvSpPr txBox="1"/>
          <p:nvPr/>
        </p:nvSpPr>
        <p:spPr>
          <a:xfrm rot="16200000">
            <a:off x="-257113" y="10947961"/>
            <a:ext cx="1029128" cy="246221"/>
          </a:xfrm>
          <a:prstGeom prst="rect">
            <a:avLst/>
          </a:prstGeom>
          <a:noFill/>
          <a:ln w="12700"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/ left S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379A352-B3D9-4E1B-AB09-1AAB3D733584}"/>
              </a:ext>
            </a:extLst>
          </p:cNvPr>
          <p:cNvSpPr txBox="1"/>
          <p:nvPr/>
        </p:nvSpPr>
        <p:spPr>
          <a:xfrm>
            <a:off x="2283185" y="909557"/>
            <a:ext cx="7982901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alivary Gland inflammatory environment (week 11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00C522E-02AF-44B2-A8FD-91835B1A3671}"/>
              </a:ext>
            </a:extLst>
          </p:cNvPr>
          <p:cNvSpPr txBox="1"/>
          <p:nvPr/>
        </p:nvSpPr>
        <p:spPr>
          <a:xfrm>
            <a:off x="147144" y="12436808"/>
            <a:ext cx="118222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/>
              <a:t>Box plots of cytokine and chemokine proteins measured in vehicle and cenerimod treated MRL/lpr mice at the end of the study (week 11). Each data point represents the measurement of individual mice; horizontal line indicates the median, the box indicates the upper and lower quartiles, and the whiskers indicate the minimum and maximum range. *p&lt;0.05, **p&lt;0.01, ***p&lt;0.001, ****p&lt;0.0001 vs. vehicle group (Mann-Whitney test). SG, salivary gland.</a:t>
            </a:r>
          </a:p>
        </p:txBody>
      </p:sp>
    </p:spTree>
    <p:extLst>
      <p:ext uri="{BB962C8B-B14F-4D97-AF65-F5344CB8AC3E}">
        <p14:creationId xmlns:p14="http://schemas.microsoft.com/office/powerpoint/2010/main" val="9886840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2C5CE8C-A811-4630-94FF-600740AA098B}"/>
              </a:ext>
            </a:extLst>
          </p:cNvPr>
          <p:cNvGrpSpPr/>
          <p:nvPr/>
        </p:nvGrpSpPr>
        <p:grpSpPr>
          <a:xfrm>
            <a:off x="699334" y="841226"/>
            <a:ext cx="6406704" cy="5210208"/>
            <a:chOff x="699334" y="841226"/>
            <a:chExt cx="6406704" cy="521020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468AEAF-A0F9-4F7A-9F2B-8ADD80B72A2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92658" y="1218996"/>
              <a:ext cx="2489835" cy="153352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0583518-C6FD-4544-9998-C93A14BCA94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92658" y="4517909"/>
              <a:ext cx="2489835" cy="1533525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9DD1A20-BEE4-47C4-A4BA-449B7148F46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92658" y="2868453"/>
              <a:ext cx="2489835" cy="153352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9D26F70-49C9-4426-8988-6623D02A25DC}"/>
                </a:ext>
              </a:extLst>
            </p:cNvPr>
            <p:cNvSpPr txBox="1"/>
            <p:nvPr/>
          </p:nvSpPr>
          <p:spPr>
            <a:xfrm>
              <a:off x="2801719" y="841226"/>
              <a:ext cx="8717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Vehicl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9984297-8527-4D21-A29A-7477355F56FE}"/>
                </a:ext>
              </a:extLst>
            </p:cNvPr>
            <p:cNvSpPr txBox="1"/>
            <p:nvPr/>
          </p:nvSpPr>
          <p:spPr>
            <a:xfrm>
              <a:off x="5250216" y="841226"/>
              <a:ext cx="12218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</a:rPr>
                <a:t>Cenerimod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1EC538C-BB43-45B0-8FD4-FE4863934A8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16203" y="1218996"/>
              <a:ext cx="2489835" cy="153352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65990FB-15FC-46E6-9E97-7D76DE919CF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16203" y="2868453"/>
              <a:ext cx="2489835" cy="153352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991A914-6378-4405-9D1A-11144B51297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616203" y="4517909"/>
              <a:ext cx="2489835" cy="153352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9FCE404-5F2B-4EED-AA04-FC5DBCEC788E}"/>
                </a:ext>
              </a:extLst>
            </p:cNvPr>
            <p:cNvSpPr txBox="1"/>
            <p:nvPr/>
          </p:nvSpPr>
          <p:spPr>
            <a:xfrm>
              <a:off x="1185043" y="1801092"/>
              <a:ext cx="801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DF0027"/>
                  </a:solidFill>
                </a:rPr>
                <a:t>CD138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3D94B1A-0A2F-4202-8351-A9217B450F3C}"/>
                </a:ext>
              </a:extLst>
            </p:cNvPr>
            <p:cNvSpPr txBox="1"/>
            <p:nvPr/>
          </p:nvSpPr>
          <p:spPr>
            <a:xfrm>
              <a:off x="1417479" y="3450549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13A124"/>
                  </a:solidFill>
                </a:rPr>
                <a:t>CD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CD0B894-544F-4E08-86A3-720CF3D64865}"/>
                </a:ext>
              </a:extLst>
            </p:cNvPr>
            <p:cNvSpPr txBox="1"/>
            <p:nvPr/>
          </p:nvSpPr>
          <p:spPr>
            <a:xfrm>
              <a:off x="699334" y="5100005"/>
              <a:ext cx="1287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DF0027"/>
                  </a:solidFill>
                </a:rPr>
                <a:t>CD138</a:t>
              </a:r>
              <a:r>
                <a:rPr lang="en-US" b="1" dirty="0"/>
                <a:t>/</a:t>
              </a:r>
              <a:r>
                <a:rPr lang="en-US" b="1" dirty="0">
                  <a:solidFill>
                    <a:srgbClr val="13A124"/>
                  </a:solidFill>
                </a:rPr>
                <a:t>CD3</a:t>
              </a:r>
            </a:p>
          </p:txBody>
        </p:sp>
      </p:grpSp>
      <p:sp>
        <p:nvSpPr>
          <p:cNvPr id="14" name="Title 1">
            <a:extLst>
              <a:ext uri="{FF2B5EF4-FFF2-40B4-BE49-F238E27FC236}">
                <a16:creationId xmlns:a16="http://schemas.microsoft.com/office/drawing/2014/main" id="{A3E33173-85EF-4AE8-A726-96623B56A272}"/>
              </a:ext>
            </a:extLst>
          </p:cNvPr>
          <p:cNvSpPr txBox="1">
            <a:spLocks/>
          </p:cNvSpPr>
          <p:nvPr/>
        </p:nvSpPr>
        <p:spPr>
          <a:xfrm>
            <a:off x="197762" y="159995"/>
            <a:ext cx="5747344" cy="426667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Supplementary figure 5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853C668-339E-4119-9746-8B04C3D2C496}"/>
              </a:ext>
            </a:extLst>
          </p:cNvPr>
          <p:cNvSpPr/>
          <p:nvPr/>
        </p:nvSpPr>
        <p:spPr>
          <a:xfrm>
            <a:off x="633573" y="6310549"/>
            <a:ext cx="677409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Representative microphotographs of salivary glands of vehicle- (left column) or cenerimod-treated (right column) MRL/lpr mice at the end of the study (week 11). The microphotographs depict CD138</a:t>
            </a:r>
            <a:r>
              <a:rPr lang="en-US" baseline="30000" dirty="0"/>
              <a:t>+</a:t>
            </a:r>
            <a:r>
              <a:rPr lang="en-US" dirty="0"/>
              <a:t> cells (red) and CD3</a:t>
            </a:r>
            <a:r>
              <a:rPr lang="en-US" baseline="30000" dirty="0"/>
              <a:t>+</a:t>
            </a:r>
            <a:r>
              <a:rPr lang="en-US" dirty="0"/>
              <a:t> T cells (green), as shown by </a:t>
            </a:r>
            <a:r>
              <a:rPr lang="en-US"/>
              <a:t>immunofluorescenc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151293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UNDODONOTDELETE" val="0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MigrationWizIdDocumentLibraryPermissions xmlns="dd6c1d3a-52d8-4447-9a4e-598e686bd39e" xsi:nil="true"/>
    <MigrationWizIdSecurityGroups xmlns="dd6c1d3a-52d8-4447-9a4e-598e686bd39e" xsi:nil="true"/>
    <MigrationWizIdPermissions xmlns="dd6c1d3a-52d8-4447-9a4e-598e686bd39e" xsi:nil="true"/>
    <MigrationWizId xmlns="dd6c1d3a-52d8-4447-9a4e-598e686bd39e" xsi:nil="true"/>
    <MigrationWizIdPermissionLevels xmlns="dd6c1d3a-52d8-4447-9a4e-598e686bd39e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DEC06A5099F2249B796F27AFB4ED835" ma:contentTypeVersion="18" ma:contentTypeDescription="Create a new document." ma:contentTypeScope="" ma:versionID="b4d6ab2ef527c6e6c99e1dbd26778b55">
  <xsd:schema xmlns:xsd="http://www.w3.org/2001/XMLSchema" xmlns:xs="http://www.w3.org/2001/XMLSchema" xmlns:p="http://schemas.microsoft.com/office/2006/metadata/properties" xmlns:ns3="dd6c1d3a-52d8-4447-9a4e-598e686bd39e" xmlns:ns4="16aab05d-5936-4c76-88f5-f42ca42e742e" targetNamespace="http://schemas.microsoft.com/office/2006/metadata/properties" ma:root="true" ma:fieldsID="d197951442766c6da24ccecbd8de16e8" ns3:_="" ns4:_="">
    <xsd:import namespace="dd6c1d3a-52d8-4447-9a4e-598e686bd39e"/>
    <xsd:import namespace="16aab05d-5936-4c76-88f5-f42ca42e742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igrationWizId" minOccurs="0"/>
                <xsd:element ref="ns3:MigrationWizIdPermissions" minOccurs="0"/>
                <xsd:element ref="ns3:MigrationWizIdPermissionLevels" minOccurs="0"/>
                <xsd:element ref="ns3:MigrationWizIdDocumentLibraryPermissions" minOccurs="0"/>
                <xsd:element ref="ns3:MigrationWizIdSecurityGroups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d6c1d3a-52d8-4447-9a4e-598e686bd3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igrationWizId" ma:index="19" nillable="true" ma:displayName="MigrationWizId" ma:internalName="MigrationWizId">
      <xsd:simpleType>
        <xsd:restriction base="dms:Text"/>
      </xsd:simpleType>
    </xsd:element>
    <xsd:element name="MigrationWizIdPermissions" ma:index="20" nillable="true" ma:displayName="MigrationWizIdPermissions" ma:internalName="MigrationWizIdPermissions">
      <xsd:simpleType>
        <xsd:restriction base="dms:Text"/>
      </xsd:simpleType>
    </xsd:element>
    <xsd:element name="MigrationWizIdPermissionLevels" ma:index="21" nillable="true" ma:displayName="MigrationWizIdPermissionLevels" ma:internalName="MigrationWizIdPermissionLevels">
      <xsd:simpleType>
        <xsd:restriction base="dms:Text"/>
      </xsd:simpleType>
    </xsd:element>
    <xsd:element name="MigrationWizIdDocumentLibraryPermissions" ma:index="22" nillable="true" ma:displayName="MigrationWizIdDocumentLibraryPermissions" ma:internalName="MigrationWizIdDocumentLibraryPermissions">
      <xsd:simpleType>
        <xsd:restriction base="dms:Text"/>
      </xsd:simpleType>
    </xsd:element>
    <xsd:element name="MigrationWizIdSecurityGroups" ma:index="23" nillable="true" ma:displayName="MigrationWizIdSecurityGroups" ma:internalName="MigrationWizIdSecurityGroups">
      <xsd:simpleType>
        <xsd:restriction base="dms:Text"/>
      </xsd:simpleType>
    </xsd:element>
    <xsd:element name="MediaServiceAutoKeyPoints" ma:index="2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6aab05d-5936-4c76-88f5-f42ca42e742e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C74874F-44DE-4BE0-A429-123D2F4613A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E2C6E61-7FC3-4703-9178-78EA1292937A}">
  <ds:schemaRefs>
    <ds:schemaRef ds:uri="dd6c1d3a-52d8-4447-9a4e-598e686bd39e"/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619768F7-B40A-4A9A-9133-8403008C876B}">
  <ds:schemaRefs>
    <ds:schemaRef ds:uri="16aab05d-5936-4c76-88f5-f42ca42e742e"/>
    <ds:schemaRef ds:uri="dd6c1d3a-52d8-4447-9a4e-598e686bd39e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73</Words>
  <Application>Microsoft Office PowerPoint</Application>
  <PresentationFormat>Custom</PresentationFormat>
  <Paragraphs>34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telle Gerossier-Creusat</dc:creator>
  <cp:lastModifiedBy>Marianne Martinic</cp:lastModifiedBy>
  <cp:revision>7</cp:revision>
  <cp:lastPrinted>2021-02-24T15:54:04Z</cp:lastPrinted>
  <dcterms:created xsi:type="dcterms:W3CDTF">2019-09-04T08:44:46Z</dcterms:created>
  <dcterms:modified xsi:type="dcterms:W3CDTF">2021-11-23T08:56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DEC06A5099F2249B796F27AFB4ED835</vt:lpwstr>
  </property>
</Properties>
</file>